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7559675" cy="10691813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5B74738-232F-438D-A285-39F55821CAB4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7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68040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78000" y="6180120"/>
            <a:ext cx="68040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85DC401-C076-4E23-B3F3-E5778C613D4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7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864600" y="249516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78000" y="618012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864600" y="618012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BAFDFDC3-3BD8-4E6C-A4BD-59F809DBAF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7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21906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678400" y="2495160"/>
            <a:ext cx="21906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979160" y="2495160"/>
            <a:ext cx="21906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78000" y="6180120"/>
            <a:ext cx="21906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678400" y="6180120"/>
            <a:ext cx="21906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979160" y="6180120"/>
            <a:ext cx="21906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9B99E47-95B0-4C8F-ABA6-0520D0E36A25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7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78000" y="2495160"/>
            <a:ext cx="6804000" cy="7054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BBC49624-382F-4D0E-A27C-6F96DE01AD5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7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6804000" cy="705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B4095DD-0D60-4535-AE64-2195E5F0254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7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3320280" cy="705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864600" y="2495160"/>
            <a:ext cx="3320280" cy="705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399F7B7-CDC6-4723-8FB8-01E76BEECE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7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FD6C777-7866-4131-9489-1C43A80E5B2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78000" y="428400"/>
            <a:ext cx="6804000" cy="8249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231335C-0AB8-4424-A682-C0B6F524665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7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864600" y="2495160"/>
            <a:ext cx="3320280" cy="705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78000" y="618012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EDF3CC3-8CD6-434E-A7D0-2A587342222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7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3320280" cy="705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864600" y="249516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864600" y="618012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0931306-C82C-40A4-B755-7A1A8235E54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7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864600" y="249516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78000" y="6180120"/>
            <a:ext cx="68040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E79B068-26B9-4471-B17E-E97AE519B98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7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78000" y="2495160"/>
            <a:ext cx="6804000" cy="705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77640" y="9910440"/>
            <a:ext cx="1763640" cy="568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fr-FR" sz="18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"/>
          <p:cNvSpPr/>
          <p:nvPr/>
        </p:nvSpPr>
        <p:spPr>
          <a:xfrm>
            <a:off x="2583000" y="9910800"/>
            <a:ext cx="2395440" cy="569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sldNum" idx="2"/>
          </p:nvPr>
        </p:nvSpPr>
        <p:spPr>
          <a:xfrm>
            <a:off x="5418000" y="9910440"/>
            <a:ext cx="1764000" cy="568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fr-FR" sz="18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fld id="{73505C51-FE83-4FAD-8065-E89CBF6CB7C7}" type="slidenum">
              <a:rPr b="0" lang="fr-FR" sz="18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.jpe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484200" y="9163080"/>
            <a:ext cx="6805440" cy="504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pPr>
              <a:spcBef>
                <a:spcPts val="300"/>
              </a:spcBef>
              <a:tabLst>
                <a:tab algn="l" pos="0"/>
                <a:tab algn="l" pos="569880"/>
                <a:tab algn="l" pos="1484280"/>
                <a:tab algn="l" pos="2398680"/>
                <a:tab algn="l" pos="3313080"/>
                <a:tab algn="l" pos="4227480"/>
                <a:tab algn="l" pos="5141880"/>
                <a:tab algn="l" pos="6056280"/>
                <a:tab algn="l" pos="6970680"/>
                <a:tab algn="l" pos="7885080"/>
                <a:tab algn="l" pos="8799480"/>
                <a:tab algn="l" pos="9713880"/>
                <a:tab algn="l" pos="10058400"/>
                <a:tab algn="l" pos="105156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Calibri"/>
                <a:ea typeface="Microsoft YaHei"/>
              </a:rPr>
              <a:t>Table S1.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  <a:ea typeface="Microsoft YaHei"/>
              </a:rPr>
              <a:t> (A) Virus strain-reference panel and (B) Viral PCR-reference panel used for determination of the LOD in the automated proces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324000" y="738360"/>
          <a:ext cx="7054200" cy="2329920"/>
        </p:xfrm>
        <a:graphic>
          <a:graphicData uri="http://schemas.openxmlformats.org/drawingml/2006/table">
            <a:tbl>
              <a:tblPr/>
              <a:tblGrid>
                <a:gridCol w="1012680"/>
                <a:gridCol w="1375200"/>
                <a:gridCol w="1063440"/>
                <a:gridCol w="1183320"/>
                <a:gridCol w="1243080"/>
                <a:gridCol w="1176480"/>
              </a:tblGrid>
              <a:tr h="763920">
                <a:tc>
                  <a:txBody>
                    <a:bodyPr lIns="73800" rIns="73800" tIns="4680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fr-FR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Virus strain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80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fr-FR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upplie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80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fr-FR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eference Panel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80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fr-FR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arget concentration log10 IU/ml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80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fr-FR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arget concentration log10 copies/ml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80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fr-FR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oncentration ct rang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9240">
                <a:tc>
                  <a:txBody>
                    <a:bodyPr lIns="73800" rIns="73800" tIns="4680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MV AD16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3">
                  <a:txBody>
                    <a:bodyPr lIns="73800" rIns="73800" tIns="4680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Qnostics Molecular “Q” Panel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80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MVMQP0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80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 to 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80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80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600">
                <a:tc>
                  <a:txBody>
                    <a:bodyPr lIns="73800" rIns="73800" tIns="4680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BV B-9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3800" rIns="73800" tIns="4680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BVMQP0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80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 to 4.5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80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80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240">
                <a:tc>
                  <a:txBody>
                    <a:bodyPr lIns="73800" rIns="73800" tIns="4680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SV1 9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3800" rIns="73800" tIns="4680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SV1MQP0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80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80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 to 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80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63920">
                <a:tc>
                  <a:txBody>
                    <a:bodyPr lIns="73800" rIns="73800" tIns="4680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HV6 Z2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80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Zeptometrix NATtrol-Molecular control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80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ATHHV6-S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80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80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80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2-2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U73 gene region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43" name=""/>
          <p:cNvGraphicFramePr/>
          <p:nvPr/>
        </p:nvGraphicFramePr>
        <p:xfrm>
          <a:off x="324000" y="3691080"/>
          <a:ext cx="6914520" cy="3418920"/>
        </p:xfrm>
        <a:graphic>
          <a:graphicData uri="http://schemas.openxmlformats.org/drawingml/2006/table">
            <a:tbl>
              <a:tblPr/>
              <a:tblGrid>
                <a:gridCol w="606240"/>
                <a:gridCol w="1052640"/>
                <a:gridCol w="808200"/>
                <a:gridCol w="1003680"/>
                <a:gridCol w="1067040"/>
                <a:gridCol w="1124280"/>
                <a:gridCol w="1252440"/>
              </a:tblGrid>
              <a:tr h="1141560"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Viru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etected gene (fragment size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eference Pane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Quantifica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andard and positive control (QS3) </a:t>
                      </a: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copies/PCR </a:t>
                      </a:r>
                      <a:r>
                        <a:rPr b="0" lang="fr-FR" sz="10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/ min-max Ct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ensivity control </a:t>
                      </a: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copies/PCR </a:t>
                      </a:r>
                      <a:r>
                        <a:rPr b="0" lang="fr-FR" sz="10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a</a:t>
                      </a: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/LOD </a:t>
                      </a: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copies/ml of whole blood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andard curv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QS4 to QS1, copies/PCR </a:t>
                      </a:r>
                      <a:r>
                        <a:rPr b="0" lang="fr-FR" sz="10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a</a:t>
                      </a: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)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ange of quantification </a:t>
                      </a: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copies/ml of plasma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31720"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MV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pUL8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283 pb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9-003B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00 / 30-3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 / 44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0-50.00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00- to 10</a:t>
                      </a:r>
                      <a:r>
                        <a:rPr b="0" lang="fr-FR" sz="10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9800"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BV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XLF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169pb)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9-002B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0 / 28-3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 / 18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-100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00 to 10</a:t>
                      </a:r>
                      <a:r>
                        <a:rPr b="0" lang="fr-FR" sz="10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9440"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SV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S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142 pb)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9-004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00 / 31-3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 / 28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0-20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00 to 10</a:t>
                      </a:r>
                      <a:r>
                        <a:rPr b="0" lang="fr-FR" sz="10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9800"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HV6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5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116 pb)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9-100B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00 / 30-3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 / ND </a:t>
                      </a:r>
                      <a:r>
                        <a:rPr b="0" lang="fr-FR" sz="10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0-50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00 to 10</a:t>
                      </a:r>
                      <a:r>
                        <a:rPr b="0" lang="fr-FR" sz="10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7160"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9440"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TV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’ UTR region</a:t>
                      </a:r>
                      <a:r>
                        <a:rPr b="1" lang="fr-FR" sz="1000" spc="-1" strike="noStrike" baseline="30000">
                          <a:solidFill>
                            <a:srgbClr val="000000"/>
                          </a:solidFill>
                          <a:latin typeface="Calibri"/>
                          <a:ea typeface="MS PGothic"/>
                        </a:rPr>
                        <a:t>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128 bp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9-030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00 / 26-3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 /  167 </a:t>
                      </a:r>
                      <a:r>
                        <a:rPr b="0" lang="fr-FR" sz="10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0-50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3800" rIns="73800" tIns="46080" bIns="3708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o 4.1 10</a:t>
                      </a:r>
                      <a:r>
                        <a:rPr b="0" lang="fr-FR" sz="10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10</a:t>
                      </a: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fr-FR" sz="10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3800" marR="73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4" name=""/>
          <p:cNvSpPr/>
          <p:nvPr/>
        </p:nvSpPr>
        <p:spPr>
          <a:xfrm>
            <a:off x="468360" y="7147080"/>
            <a:ext cx="6769080" cy="140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fr-FR" sz="1800" spc="-1" strike="noStrike" baseline="30000">
                <a:solidFill>
                  <a:srgbClr val="000000"/>
                </a:solidFill>
                <a:latin typeface="Calibri"/>
                <a:ea typeface="MS PGothic"/>
              </a:rPr>
              <a:t>a</a:t>
            </a:r>
            <a:r>
              <a:rPr b="0" lang="fr-FR" sz="1800" spc="-1" strike="noStrike">
                <a:solidFill>
                  <a:srgbClr val="000000"/>
                </a:solidFill>
                <a:latin typeface="Calibri"/>
                <a:ea typeface="MS PGothic"/>
              </a:rPr>
              <a:t> 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  <a:ea typeface="MS PGothic"/>
              </a:rPr>
              <a:t>X copies/PCR are equivalent to 25*X copies/ml of plasm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fr-FR" sz="1400" spc="-1" strike="noStrike" baseline="30000">
                <a:solidFill>
                  <a:srgbClr val="000000"/>
                </a:solidFill>
                <a:latin typeface="Calibri"/>
                <a:ea typeface="MS PGothic"/>
              </a:rPr>
              <a:t>b</a:t>
            </a:r>
            <a:r>
              <a:rPr b="0" lang="fr-FR" sz="1400" spc="-1" strike="noStrike">
                <a:solidFill>
                  <a:srgbClr val="000000"/>
                </a:solidFill>
                <a:latin typeface="Calibri"/>
                <a:ea typeface="MS PGothic"/>
              </a:rPr>
              <a:t> 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  <a:ea typeface="MS PGothic"/>
              </a:rPr>
              <a:t>not determine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fr-FR" sz="1400" spc="-1" strike="noStrike" baseline="30000">
                <a:solidFill>
                  <a:srgbClr val="000000"/>
                </a:solidFill>
                <a:latin typeface="Calibri"/>
                <a:ea typeface="MS PGothic"/>
              </a:rPr>
              <a:t>c</a:t>
            </a:r>
            <a:r>
              <a:rPr b="0" lang="fr-FR" sz="1400" spc="-1" strike="noStrike">
                <a:solidFill>
                  <a:srgbClr val="000000"/>
                </a:solidFill>
                <a:latin typeface="Calibri"/>
                <a:ea typeface="MS PGothic"/>
              </a:rPr>
              <a:t> 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  <a:ea typeface="MS PGothic"/>
              </a:rPr>
              <a:t>defined on plasm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fr-FR" sz="1400" spc="-1" strike="noStrike" baseline="30000">
                <a:solidFill>
                  <a:srgbClr val="000000"/>
                </a:solidFill>
                <a:latin typeface="Calibri"/>
                <a:ea typeface="MS PGothic"/>
              </a:rPr>
              <a:t>d</a:t>
            </a:r>
            <a:r>
              <a:rPr b="0" lang="fr-FR" sz="1400" spc="-1" strike="noStrike">
                <a:solidFill>
                  <a:srgbClr val="000000"/>
                </a:solidFill>
                <a:latin typeface="Calibri"/>
                <a:ea typeface="MS PGothic"/>
              </a:rPr>
              <a:t> 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  <a:ea typeface="MS PGothic"/>
              </a:rPr>
              <a:t>defined on whole bloo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fr-FR" sz="1400" spc="-1" strike="noStrike" baseline="30000">
                <a:solidFill>
                  <a:srgbClr val="000000"/>
                </a:solidFill>
                <a:latin typeface="Calibri"/>
                <a:ea typeface="MS PGothic"/>
              </a:rPr>
              <a:t>e</a:t>
            </a:r>
            <a:r>
              <a:rPr b="1" lang="fr-FR" sz="1400" spc="-1" strike="noStrike">
                <a:solidFill>
                  <a:srgbClr val="000000"/>
                </a:solidFill>
                <a:latin typeface="Calibri"/>
                <a:ea typeface="MS PGothic"/>
              </a:rPr>
              <a:t> </a:t>
            </a:r>
            <a:r>
              <a:rPr b="0" lang="nl-NL" sz="1200" spc="-1" strike="noStrike">
                <a:solidFill>
                  <a:srgbClr val="000000"/>
                </a:solidFill>
                <a:latin typeface="Calibri"/>
                <a:ea typeface="MS PGothic"/>
              </a:rPr>
              <a:t>TTV genotypes 1, 3, 6, 7, 8, 10, 12, 15, 16, 19, 27, 28 (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MS PGothic"/>
              </a:rPr>
              <a:t>available for Research Use Only, not for use in diagnostic procedure, bioMérieux, France)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"/>
          <p:cNvSpPr/>
          <p:nvPr/>
        </p:nvSpPr>
        <p:spPr>
          <a:xfrm>
            <a:off x="309600" y="30636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  <a:ea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"/>
          <p:cNvSpPr/>
          <p:nvPr/>
        </p:nvSpPr>
        <p:spPr>
          <a:xfrm>
            <a:off x="309960" y="325908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  <a:ea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7" name=""/>
          <p:cNvGrpSpPr/>
          <p:nvPr/>
        </p:nvGrpSpPr>
        <p:grpSpPr>
          <a:xfrm>
            <a:off x="176040" y="233280"/>
            <a:ext cx="7604640" cy="4470480"/>
            <a:chOff x="176040" y="233280"/>
            <a:chExt cx="7604640" cy="4470480"/>
          </a:xfrm>
        </p:grpSpPr>
        <p:sp>
          <p:nvSpPr>
            <p:cNvPr id="48" name=""/>
            <p:cNvSpPr/>
            <p:nvPr/>
          </p:nvSpPr>
          <p:spPr>
            <a:xfrm>
              <a:off x="2922120" y="233280"/>
              <a:ext cx="2617920" cy="482760"/>
            </a:xfrm>
            <a:prstGeom prst="roundRect">
              <a:avLst>
                <a:gd name="adj" fmla="val 16667"/>
              </a:avLst>
            </a:pr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6000" rIns="36000" tIns="36000" bIns="360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fr-FR" sz="14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Total </a:t>
              </a:r>
              <a:r>
                <a:rPr b="1" lang="fr-FR" sz="14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enrolled patients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fr-FR" sz="14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N=749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1003680" y="1079640"/>
              <a:ext cx="1957680" cy="360360"/>
            </a:xfrm>
            <a:prstGeom prst="rect">
              <a:avLst/>
            </a:prstGeom>
            <a:solidFill>
              <a:srgbClr val="f2f2f2"/>
            </a:solidFill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6000" rIns="36000" tIns="36000" bIns="360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fr-FR" sz="16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SIRS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3251520" y="1079640"/>
              <a:ext cx="1957320" cy="360360"/>
            </a:xfrm>
            <a:prstGeom prst="rect">
              <a:avLst/>
            </a:prstGeom>
            <a:solidFill>
              <a:srgbClr val="f2f2f2"/>
            </a:solidFill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6000" rIns="36000" tIns="36000" bIns="360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fr-FR" sz="16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Sepsis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5582880" y="1079640"/>
              <a:ext cx="1957320" cy="360360"/>
            </a:xfrm>
            <a:prstGeom prst="rect">
              <a:avLst/>
            </a:prstGeom>
            <a:solidFill>
              <a:srgbClr val="f2f2f2"/>
            </a:solidFill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6000" rIns="36000" tIns="36000" bIns="360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fr-FR" sz="16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Septic shock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176040" y="1684440"/>
              <a:ext cx="705240" cy="541080"/>
            </a:xfrm>
            <a:prstGeom prst="rect">
              <a:avLst/>
            </a:prstGeom>
            <a:solidFill>
              <a:srgbClr val="f2f2f2"/>
            </a:solidFill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6000" rIns="36000" tIns="36000" bIns="360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fr-FR" sz="16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ay 1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176040" y="2917800"/>
              <a:ext cx="705240" cy="541440"/>
            </a:xfrm>
            <a:prstGeom prst="rect">
              <a:avLst/>
            </a:prstGeom>
            <a:solidFill>
              <a:srgbClr val="f2f2f2"/>
            </a:solidFill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6000" rIns="36000" tIns="36000" bIns="360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fr-FR" sz="16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ay 3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176040" y="4162320"/>
              <a:ext cx="705240" cy="541440"/>
            </a:xfrm>
            <a:prstGeom prst="rect">
              <a:avLst/>
            </a:prstGeom>
            <a:solidFill>
              <a:srgbClr val="f2f2f2"/>
            </a:solidFill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6000" rIns="36000" tIns="36000" bIns="360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fr-FR" sz="16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ay 6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1003680" y="1681200"/>
              <a:ext cx="1957680" cy="542880"/>
            </a:xfrm>
            <a:prstGeom prst="roundRect">
              <a:avLst>
                <a:gd name="adj" fmla="val 16667"/>
              </a:avLst>
            </a:pr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6000" rIns="36000" tIns="36000" bIns="360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Enrolled patients N=23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Analyzable samples n=219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1003680" y="2921040"/>
              <a:ext cx="1957680" cy="541440"/>
            </a:xfrm>
            <a:prstGeom prst="roundRect">
              <a:avLst>
                <a:gd name="adj" fmla="val 16667"/>
              </a:avLst>
            </a:pr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6000" rIns="36000" tIns="36000" bIns="360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Enrolled patients N=17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Analyzable samples n=13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1003680" y="4160880"/>
              <a:ext cx="1957680" cy="541440"/>
            </a:xfrm>
            <a:prstGeom prst="roundRect">
              <a:avLst>
                <a:gd name="adj" fmla="val 16667"/>
              </a:avLst>
            </a:pr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6000" rIns="36000" tIns="36000" bIns="360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Enrolled patients N=8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Analyzable samples n=7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3253320" y="1681200"/>
              <a:ext cx="1955520" cy="542880"/>
            </a:xfrm>
            <a:prstGeom prst="roundRect">
              <a:avLst>
                <a:gd name="adj" fmla="val 16667"/>
              </a:avLst>
            </a:pr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6000" rIns="36000" tIns="36000" bIns="360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Enrolled patients N=25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Analyzable samples n=25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3253320" y="2921040"/>
              <a:ext cx="1955520" cy="541440"/>
            </a:xfrm>
            <a:prstGeom prst="roundRect">
              <a:avLst>
                <a:gd name="adj" fmla="val 16667"/>
              </a:avLst>
            </a:pr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6000" rIns="36000" tIns="36000" bIns="360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Enrolled patients N=238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Analyzable samples n=18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3253320" y="4160880"/>
              <a:ext cx="1955520" cy="541440"/>
            </a:xfrm>
            <a:prstGeom prst="roundRect">
              <a:avLst>
                <a:gd name="adj" fmla="val 16667"/>
              </a:avLst>
            </a:pr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6000" rIns="36000" tIns="36000" bIns="360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Enrolled patients N=13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Analyzable samples n=12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5582880" y="1681200"/>
              <a:ext cx="1957320" cy="542880"/>
            </a:xfrm>
            <a:prstGeom prst="roundRect">
              <a:avLst>
                <a:gd name="adj" fmla="val 16667"/>
              </a:avLst>
            </a:pr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6000" rIns="36000" tIns="36000" bIns="360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Enrolled patients N=26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Analyzable samples n=25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5582880" y="2921040"/>
              <a:ext cx="1957320" cy="541440"/>
            </a:xfrm>
            <a:prstGeom prst="roundRect">
              <a:avLst>
                <a:gd name="adj" fmla="val 16667"/>
              </a:avLst>
            </a:pr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6000" rIns="36000" tIns="36000" bIns="360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Enrolled patients N=209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Analyzable samples n=16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5582880" y="4160880"/>
              <a:ext cx="1957320" cy="541440"/>
            </a:xfrm>
            <a:prstGeom prst="roundRect">
              <a:avLst>
                <a:gd name="adj" fmla="val 16667"/>
              </a:avLst>
            </a:pr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6000" rIns="36000" tIns="36000" bIns="360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Enrolled patients N=14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Analyzable samples n=12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2026800" y="2214720"/>
              <a:ext cx="1932840" cy="726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36000" rIns="36000" tIns="36000" bIns="36000" anchor="ctr">
              <a:noAutofit/>
            </a:bodyPr>
            <a:p>
              <a:pPr marL="81000" indent="-81000">
                <a:buClr>
                  <a:srgbClr val="000000"/>
                </a:buClr>
                <a:buFont typeface="Calibri"/>
                <a:buChar char="-"/>
                <a:tabLst>
                  <a:tab algn="l" pos="81000"/>
                  <a:tab algn="l" pos="995400"/>
                  <a:tab algn="l" pos="1909800"/>
                  <a:tab algn="l" pos="2824200"/>
                  <a:tab algn="l" pos="3738600"/>
                  <a:tab algn="l" pos="4653000"/>
                  <a:tab algn="l" pos="5567400"/>
                  <a:tab algn="l" pos="6481800"/>
                  <a:tab algn="l" pos="7396200"/>
                  <a:tab algn="l" pos="8310600"/>
                  <a:tab algn="l" pos="9225000"/>
                  <a:tab algn="l" pos="10139400"/>
                  <a:tab algn="l" pos="10515600"/>
                </a:tabLst>
              </a:pPr>
              <a:r>
                <a:rPr b="0" i="1" lang="fr-FR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ischarge alive n=1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marL="81000" indent="-81000">
                <a:buClr>
                  <a:srgbClr val="000000"/>
                </a:buClr>
                <a:buFont typeface="Calibri"/>
                <a:buChar char="-"/>
                <a:tabLst>
                  <a:tab algn="l" pos="81000"/>
                  <a:tab algn="l" pos="995400"/>
                  <a:tab algn="l" pos="1909800"/>
                  <a:tab algn="l" pos="2824200"/>
                  <a:tab algn="l" pos="3738600"/>
                  <a:tab algn="l" pos="4653000"/>
                  <a:tab algn="l" pos="5567400"/>
                  <a:tab algn="l" pos="6481800"/>
                  <a:tab algn="l" pos="7396200"/>
                  <a:tab algn="l" pos="8310600"/>
                  <a:tab algn="l" pos="9225000"/>
                  <a:tab algn="l" pos="10139400"/>
                  <a:tab algn="l" pos="10515600"/>
                </a:tabLst>
              </a:pPr>
              <a:r>
                <a:rPr b="0" i="1" lang="fr-FR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eath n=3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marL="81000" indent="-81000">
                <a:buClr>
                  <a:srgbClr val="000000"/>
                </a:buClr>
                <a:buFont typeface="Calibri"/>
                <a:buChar char="-"/>
                <a:tabLst>
                  <a:tab algn="l" pos="81000"/>
                  <a:tab algn="l" pos="995400"/>
                  <a:tab algn="l" pos="1909800"/>
                  <a:tab algn="l" pos="2824200"/>
                  <a:tab algn="l" pos="3738600"/>
                  <a:tab algn="l" pos="4653000"/>
                  <a:tab algn="l" pos="5567400"/>
                  <a:tab algn="l" pos="6481800"/>
                  <a:tab algn="l" pos="7396200"/>
                  <a:tab algn="l" pos="8310600"/>
                  <a:tab algn="l" pos="9225000"/>
                  <a:tab algn="l" pos="10139400"/>
                  <a:tab algn="l" pos="10515600"/>
                </a:tabLst>
              </a:pPr>
              <a:r>
                <a:rPr b="0" i="1" lang="fr-FR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IAI n=15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2026800" y="3460680"/>
              <a:ext cx="1821240" cy="727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36000" rIns="36000" tIns="36000" bIns="36000" anchor="ctr">
              <a:noAutofit/>
            </a:bodyPr>
            <a:p>
              <a:pPr marL="81000" indent="-81000">
                <a:buClr>
                  <a:srgbClr val="000000"/>
                </a:buClr>
                <a:buFont typeface="Calibri"/>
                <a:buChar char="-"/>
                <a:tabLst>
                  <a:tab algn="l" pos="81000"/>
                  <a:tab algn="l" pos="995400"/>
                  <a:tab algn="l" pos="1909800"/>
                  <a:tab algn="l" pos="2824200"/>
                  <a:tab algn="l" pos="3738600"/>
                  <a:tab algn="l" pos="4653000"/>
                  <a:tab algn="l" pos="5567400"/>
                  <a:tab algn="l" pos="6481800"/>
                  <a:tab algn="l" pos="7396200"/>
                  <a:tab algn="l" pos="8310600"/>
                  <a:tab algn="l" pos="9225000"/>
                  <a:tab algn="l" pos="10139400"/>
                  <a:tab algn="l" pos="10515600"/>
                </a:tabLst>
              </a:pPr>
              <a:r>
                <a:rPr b="0" i="1" lang="fr-FR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ischarge alive n=5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marL="81000" indent="-81000">
                <a:buClr>
                  <a:srgbClr val="000000"/>
                </a:buClr>
                <a:buFont typeface="Calibri"/>
                <a:buChar char="-"/>
                <a:tabLst>
                  <a:tab algn="l" pos="81000"/>
                  <a:tab algn="l" pos="995400"/>
                  <a:tab algn="l" pos="1909800"/>
                  <a:tab algn="l" pos="2824200"/>
                  <a:tab algn="l" pos="3738600"/>
                  <a:tab algn="l" pos="4653000"/>
                  <a:tab algn="l" pos="5567400"/>
                  <a:tab algn="l" pos="6481800"/>
                  <a:tab algn="l" pos="7396200"/>
                  <a:tab algn="l" pos="8310600"/>
                  <a:tab algn="l" pos="9225000"/>
                  <a:tab algn="l" pos="10139400"/>
                  <a:tab algn="l" pos="10515600"/>
                </a:tabLst>
              </a:pPr>
              <a:r>
                <a:rPr b="0" i="1" lang="fr-FR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eath n=1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marL="81000" indent="-81000">
                <a:buClr>
                  <a:srgbClr val="000000"/>
                </a:buClr>
                <a:buFont typeface="Calibri"/>
                <a:buChar char="-"/>
                <a:tabLst>
                  <a:tab algn="l" pos="81000"/>
                  <a:tab algn="l" pos="995400"/>
                  <a:tab algn="l" pos="1909800"/>
                  <a:tab algn="l" pos="2824200"/>
                  <a:tab algn="l" pos="3738600"/>
                  <a:tab algn="l" pos="4653000"/>
                  <a:tab algn="l" pos="5567400"/>
                  <a:tab algn="l" pos="6481800"/>
                  <a:tab algn="l" pos="7396200"/>
                  <a:tab algn="l" pos="8310600"/>
                  <a:tab algn="l" pos="9225000"/>
                  <a:tab algn="l" pos="10139400"/>
                  <a:tab algn="l" pos="10515600"/>
                </a:tabLst>
              </a:pPr>
              <a:r>
                <a:rPr b="0" i="1" lang="fr-FR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IAI n=18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4258440" y="2214720"/>
              <a:ext cx="1822680" cy="726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36000" rIns="36000" tIns="36000" bIns="36000" anchor="ctr">
              <a:noAutofit/>
            </a:bodyPr>
            <a:p>
              <a:pPr marL="81000" indent="-81000">
                <a:buClr>
                  <a:srgbClr val="000000"/>
                </a:buClr>
                <a:buFont typeface="Calibri"/>
                <a:buChar char="-"/>
                <a:tabLst>
                  <a:tab algn="l" pos="81000"/>
                  <a:tab algn="l" pos="995400"/>
                  <a:tab algn="l" pos="1909800"/>
                  <a:tab algn="l" pos="2824200"/>
                  <a:tab algn="l" pos="3738600"/>
                  <a:tab algn="l" pos="4653000"/>
                  <a:tab algn="l" pos="5567400"/>
                  <a:tab algn="l" pos="6481800"/>
                  <a:tab algn="l" pos="7396200"/>
                  <a:tab algn="l" pos="8310600"/>
                  <a:tab algn="l" pos="9225000"/>
                  <a:tab algn="l" pos="10139400"/>
                  <a:tab algn="l" pos="10515600"/>
                </a:tabLst>
              </a:pPr>
              <a:r>
                <a:rPr b="0" i="1" lang="fr-FR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ischarge alive n=1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marL="81000" indent="-81000">
                <a:buClr>
                  <a:srgbClr val="000000"/>
                </a:buClr>
                <a:buFont typeface="Calibri"/>
                <a:buChar char="-"/>
                <a:tabLst>
                  <a:tab algn="l" pos="81000"/>
                  <a:tab algn="l" pos="995400"/>
                  <a:tab algn="l" pos="1909800"/>
                  <a:tab algn="l" pos="2824200"/>
                  <a:tab algn="l" pos="3738600"/>
                  <a:tab algn="l" pos="4653000"/>
                  <a:tab algn="l" pos="5567400"/>
                  <a:tab algn="l" pos="6481800"/>
                  <a:tab algn="l" pos="7396200"/>
                  <a:tab algn="l" pos="8310600"/>
                  <a:tab algn="l" pos="9225000"/>
                  <a:tab algn="l" pos="10139400"/>
                  <a:tab algn="l" pos="10515600"/>
                </a:tabLst>
              </a:pPr>
              <a:r>
                <a:rPr b="0" i="1" lang="fr-FR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eath n=4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marL="81000" indent="-81000">
                <a:buClr>
                  <a:srgbClr val="000000"/>
                </a:buClr>
                <a:buFont typeface="Calibri"/>
                <a:buChar char="-"/>
                <a:tabLst>
                  <a:tab algn="l" pos="81000"/>
                  <a:tab algn="l" pos="995400"/>
                  <a:tab algn="l" pos="1909800"/>
                  <a:tab algn="l" pos="2824200"/>
                  <a:tab algn="l" pos="3738600"/>
                  <a:tab algn="l" pos="4653000"/>
                  <a:tab algn="l" pos="5567400"/>
                  <a:tab algn="l" pos="6481800"/>
                  <a:tab algn="l" pos="7396200"/>
                  <a:tab algn="l" pos="8310600"/>
                  <a:tab algn="l" pos="9225000"/>
                  <a:tab algn="l" pos="10139400"/>
                  <a:tab algn="l" pos="10515600"/>
                </a:tabLst>
              </a:pPr>
              <a:r>
                <a:rPr b="0" i="1" lang="fr-FR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IAI n=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4258440" y="3460680"/>
              <a:ext cx="1822680" cy="727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36000" rIns="36000" tIns="36000" bIns="36000" anchor="ctr">
              <a:noAutofit/>
            </a:bodyPr>
            <a:p>
              <a:pPr marL="81000" indent="-81000">
                <a:buClr>
                  <a:srgbClr val="000000"/>
                </a:buClr>
                <a:buFont typeface="Calibri"/>
                <a:buChar char="-"/>
                <a:tabLst>
                  <a:tab algn="l" pos="81000"/>
                  <a:tab algn="l" pos="995400"/>
                  <a:tab algn="l" pos="1909800"/>
                  <a:tab algn="l" pos="2824200"/>
                  <a:tab algn="l" pos="3738600"/>
                  <a:tab algn="l" pos="4653000"/>
                  <a:tab algn="l" pos="5567400"/>
                  <a:tab algn="l" pos="6481800"/>
                  <a:tab algn="l" pos="7396200"/>
                  <a:tab algn="l" pos="8310600"/>
                  <a:tab algn="l" pos="9225000"/>
                  <a:tab algn="l" pos="10139400"/>
                  <a:tab algn="l" pos="10515600"/>
                </a:tabLst>
              </a:pPr>
              <a:r>
                <a:rPr b="0" i="1" lang="fr-FR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ischarge alive n=8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marL="81000" indent="-81000">
                <a:buClr>
                  <a:srgbClr val="000000"/>
                </a:buClr>
                <a:buFont typeface="Calibri"/>
                <a:buChar char="-"/>
                <a:tabLst>
                  <a:tab algn="l" pos="81000"/>
                  <a:tab algn="l" pos="995400"/>
                  <a:tab algn="l" pos="1909800"/>
                  <a:tab algn="l" pos="2824200"/>
                  <a:tab algn="l" pos="3738600"/>
                  <a:tab algn="l" pos="4653000"/>
                  <a:tab algn="l" pos="5567400"/>
                  <a:tab algn="l" pos="6481800"/>
                  <a:tab algn="l" pos="7396200"/>
                  <a:tab algn="l" pos="8310600"/>
                  <a:tab algn="l" pos="9225000"/>
                  <a:tab algn="l" pos="10139400"/>
                  <a:tab algn="l" pos="10515600"/>
                </a:tabLst>
              </a:pPr>
              <a:r>
                <a:rPr b="0" i="1" lang="fr-FR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Death n=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marL="81000" indent="-81000">
                <a:buClr>
                  <a:srgbClr val="000000"/>
                </a:buClr>
                <a:buFont typeface="Calibri"/>
                <a:buChar char="-"/>
                <a:tabLst>
                  <a:tab algn="l" pos="81000"/>
                  <a:tab algn="l" pos="995400"/>
                  <a:tab algn="l" pos="1909800"/>
                  <a:tab algn="l" pos="2824200"/>
                  <a:tab algn="l" pos="3738600"/>
                  <a:tab algn="l" pos="4653000"/>
                  <a:tab algn="l" pos="5567400"/>
                  <a:tab algn="l" pos="6481800"/>
                  <a:tab algn="l" pos="7396200"/>
                  <a:tab algn="l" pos="8310600"/>
                  <a:tab algn="l" pos="9225000"/>
                  <a:tab algn="l" pos="10139400"/>
                  <a:tab algn="l" pos="10515600"/>
                </a:tabLst>
              </a:pPr>
              <a:r>
                <a:rPr b="0" i="1" lang="fr-FR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IAI n=1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68" name=""/>
            <p:cNvCxnSpPr>
              <a:stCxn id="55" idx="2"/>
              <a:endCxn id="56" idx="0"/>
            </p:cNvCxnSpPr>
            <p:nvPr/>
          </p:nvCxnSpPr>
          <p:spPr>
            <a:xfrm>
              <a:off x="1982160" y="2225520"/>
              <a:ext cx="1080" cy="696240"/>
            </a:xfrm>
            <a:prstGeom prst="straightConnector1">
              <a:avLst/>
            </a:prstGeom>
            <a:ln cap="sq"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69" name=""/>
            <p:cNvCxnSpPr>
              <a:stCxn id="58" idx="2"/>
              <a:endCxn id="59" idx="0"/>
            </p:cNvCxnSpPr>
            <p:nvPr/>
          </p:nvCxnSpPr>
          <p:spPr>
            <a:xfrm>
              <a:off x="4231440" y="2225520"/>
              <a:ext cx="1080" cy="696240"/>
            </a:xfrm>
            <a:prstGeom prst="straightConnector1">
              <a:avLst/>
            </a:prstGeom>
            <a:ln cap="sq"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70" name=""/>
            <p:cNvCxnSpPr>
              <a:stCxn id="61" idx="2"/>
              <a:endCxn id="62" idx="0"/>
            </p:cNvCxnSpPr>
            <p:nvPr/>
          </p:nvCxnSpPr>
          <p:spPr>
            <a:xfrm>
              <a:off x="6561000" y="2225520"/>
              <a:ext cx="1080" cy="696240"/>
            </a:xfrm>
            <a:prstGeom prst="straightConnector1">
              <a:avLst/>
            </a:prstGeom>
            <a:ln cap="sq"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71" name=""/>
            <p:cNvCxnSpPr>
              <a:stCxn id="62" idx="2"/>
              <a:endCxn id="63" idx="0"/>
            </p:cNvCxnSpPr>
            <p:nvPr/>
          </p:nvCxnSpPr>
          <p:spPr>
            <a:xfrm>
              <a:off x="6561000" y="3463560"/>
              <a:ext cx="1080" cy="695520"/>
            </a:xfrm>
            <a:prstGeom prst="straightConnector1">
              <a:avLst/>
            </a:prstGeom>
            <a:ln cap="sq"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72" name=""/>
            <p:cNvCxnSpPr>
              <a:stCxn id="59" idx="2"/>
              <a:endCxn id="60" idx="0"/>
            </p:cNvCxnSpPr>
            <p:nvPr/>
          </p:nvCxnSpPr>
          <p:spPr>
            <a:xfrm>
              <a:off x="4231440" y="3463560"/>
              <a:ext cx="1080" cy="695520"/>
            </a:xfrm>
            <a:prstGeom prst="straightConnector1">
              <a:avLst/>
            </a:prstGeom>
            <a:ln cap="sq"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73" name=""/>
            <p:cNvCxnSpPr>
              <a:stCxn id="56" idx="2"/>
              <a:endCxn id="57" idx="0"/>
            </p:cNvCxnSpPr>
            <p:nvPr/>
          </p:nvCxnSpPr>
          <p:spPr>
            <a:xfrm>
              <a:off x="1982160" y="3463560"/>
              <a:ext cx="1080" cy="695520"/>
            </a:xfrm>
            <a:prstGeom prst="straightConnector1">
              <a:avLst/>
            </a:prstGeom>
            <a:ln cap="sq"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74" name=""/>
            <p:cNvCxnSpPr>
              <a:stCxn id="48" idx="2"/>
              <a:endCxn id="49" idx="0"/>
            </p:cNvCxnSpPr>
            <p:nvPr/>
          </p:nvCxnSpPr>
          <p:spPr>
            <a:xfrm rot="5400000">
              <a:off x="2926080" y="-227160"/>
              <a:ext cx="361080" cy="2249640"/>
            </a:xfrm>
            <a:prstGeom prst="bentConnector5">
              <a:avLst>
                <a:gd name="adj1" fmla="val 264371"/>
                <a:gd name="adj2" fmla="val 154273"/>
                <a:gd name="adj3" fmla="val 35329"/>
              </a:avLst>
            </a:prstGeom>
            <a:ln cap="sq"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75" name=""/>
            <p:cNvCxnSpPr>
              <a:stCxn id="48" idx="2"/>
              <a:endCxn id="51" idx="0"/>
            </p:cNvCxnSpPr>
            <p:nvPr/>
          </p:nvCxnSpPr>
          <p:spPr>
            <a:xfrm flipH="1" rot="16200000">
              <a:off x="5216040" y="-267480"/>
              <a:ext cx="361080" cy="2329920"/>
            </a:xfrm>
            <a:prstGeom prst="bentConnector5">
              <a:avLst>
                <a:gd name="adj1" fmla="val 264371"/>
                <a:gd name="adj2" fmla="val 152341"/>
                <a:gd name="adj3" fmla="val 35329"/>
              </a:avLst>
            </a:prstGeom>
            <a:ln cap="sq"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76" name=""/>
            <p:cNvCxnSpPr>
              <a:stCxn id="49" idx="2"/>
              <a:endCxn id="55" idx="0"/>
            </p:cNvCxnSpPr>
            <p:nvPr/>
          </p:nvCxnSpPr>
          <p:spPr>
            <a:xfrm>
              <a:off x="1982160" y="1441080"/>
              <a:ext cx="1080" cy="238680"/>
            </a:xfrm>
            <a:prstGeom prst="straightConnector1">
              <a:avLst/>
            </a:prstGeom>
            <a:ln cap="sq"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77" name=""/>
            <p:cNvCxnSpPr>
              <a:stCxn id="50" idx="2"/>
              <a:endCxn id="58" idx="0"/>
            </p:cNvCxnSpPr>
            <p:nvPr/>
          </p:nvCxnSpPr>
          <p:spPr>
            <a:xfrm>
              <a:off x="4230000" y="1441080"/>
              <a:ext cx="1080" cy="238680"/>
            </a:xfrm>
            <a:prstGeom prst="straightConnector1">
              <a:avLst/>
            </a:prstGeom>
            <a:ln cap="sq"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78" name=""/>
            <p:cNvCxnSpPr>
              <a:stCxn id="51" idx="2"/>
              <a:endCxn id="61" idx="0"/>
            </p:cNvCxnSpPr>
            <p:nvPr/>
          </p:nvCxnSpPr>
          <p:spPr>
            <a:xfrm>
              <a:off x="6561000" y="1441080"/>
              <a:ext cx="1080" cy="238680"/>
            </a:xfrm>
            <a:prstGeom prst="straightConnector1">
              <a:avLst/>
            </a:prstGeom>
            <a:ln cap="sq"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79" name=""/>
            <p:cNvCxnSpPr>
              <a:stCxn id="48" idx="2"/>
              <a:endCxn id="50" idx="0"/>
            </p:cNvCxnSpPr>
            <p:nvPr/>
          </p:nvCxnSpPr>
          <p:spPr>
            <a:xfrm flipH="1">
              <a:off x="4229640" y="717120"/>
              <a:ext cx="1080" cy="361080"/>
            </a:xfrm>
            <a:prstGeom prst="straightConnector1">
              <a:avLst/>
            </a:prstGeom>
            <a:ln cap="sq" w="12600">
              <a:solidFill>
                <a:srgbClr val="000000"/>
              </a:solidFill>
              <a:miter/>
              <a:tailEnd len="med" type="arrow" w="med"/>
            </a:ln>
          </p:spPr>
        </p:cxnSp>
      </p:grpSp>
      <p:sp>
        <p:nvSpPr>
          <p:cNvPr id="80" name=""/>
          <p:cNvSpPr/>
          <p:nvPr/>
        </p:nvSpPr>
        <p:spPr>
          <a:xfrm>
            <a:off x="2658960" y="5119560"/>
            <a:ext cx="2592360" cy="730440"/>
          </a:xfrm>
          <a:prstGeom prst="rect">
            <a:avLst/>
          </a:prstGeom>
          <a:noFill/>
          <a:ln cap="sq"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341280" indent="-341280">
              <a:spcBef>
                <a:spcPts val="349"/>
              </a:spcBef>
              <a:buClr>
                <a:srgbClr val="000000"/>
              </a:buClr>
              <a:buFont typeface="Arial"/>
              <a:buChar char="•"/>
              <a:tabLst>
                <a:tab algn="l" pos="341280"/>
                <a:tab algn="l" pos="1255680"/>
                <a:tab algn="l" pos="2170080"/>
                <a:tab algn="l" pos="3084480"/>
                <a:tab algn="l" pos="3998880"/>
                <a:tab algn="l" pos="4913280"/>
                <a:tab algn="l" pos="5827680"/>
                <a:tab algn="l" pos="6742080"/>
                <a:tab algn="l" pos="7656480"/>
                <a:tab algn="l" pos="8570880"/>
                <a:tab algn="l" pos="9485280"/>
                <a:tab algn="l" pos="10399680"/>
                <a:tab algn="l" pos="105156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98 septic shock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marL="341280" indent="-341280">
              <a:spcBef>
                <a:spcPts val="349"/>
              </a:spcBef>
              <a:buClr>
                <a:srgbClr val="000000"/>
              </a:buClr>
              <a:buFont typeface="Arial"/>
              <a:buChar char="•"/>
              <a:tabLst>
                <a:tab algn="l" pos="341280"/>
                <a:tab algn="l" pos="1255680"/>
                <a:tab algn="l" pos="2170080"/>
                <a:tab algn="l" pos="3084480"/>
                <a:tab algn="l" pos="3998880"/>
                <a:tab algn="l" pos="4913280"/>
                <a:tab algn="l" pos="5827680"/>
                <a:tab algn="l" pos="6742080"/>
                <a:tab algn="l" pos="7656480"/>
                <a:tab algn="l" pos="8570880"/>
                <a:tab algn="l" pos="9485280"/>
                <a:tab algn="l" pos="10399680"/>
                <a:tab algn="l" pos="105156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available plasma samples at D1, D3 and D6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81" name=""/>
          <p:cNvGraphicFramePr/>
          <p:nvPr/>
        </p:nvGraphicFramePr>
        <p:xfrm>
          <a:off x="612720" y="6138720"/>
          <a:ext cx="6697440" cy="4086000"/>
        </p:xfrm>
        <a:graphic>
          <a:graphicData uri="http://schemas.openxmlformats.org/drawingml/2006/table">
            <a:tbl>
              <a:tblPr/>
              <a:tblGrid>
                <a:gridCol w="2159280"/>
                <a:gridCol w="2521800"/>
                <a:gridCol w="2016360"/>
              </a:tblGrid>
              <a:tr h="640080">
                <a:tc>
                  <a:txBody>
                    <a:bodyPr lIns="15480" rIns="15480" tIns="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MS Mincho"/>
                        </a:rPr>
                        <a:t>Variabl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MS Mincho"/>
                        </a:rPr>
                        <a:t>Whole Septic shock cohor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MS Mincho"/>
                        </a:rPr>
                        <a:t>N = 25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fr-FR" sz="1400" spc="-1" strike="noStrike">
                          <a:solidFill>
                            <a:srgbClr val="ff0000"/>
                          </a:solidFill>
                          <a:latin typeface="Calibri"/>
                          <a:ea typeface="MS Mincho"/>
                        </a:rPr>
                        <a:t>Selected subset cohor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ff0000"/>
                          </a:solidFill>
                          <a:latin typeface="Calibri"/>
                          <a:ea typeface="MS Mincho"/>
                        </a:rPr>
                        <a:t>N = 9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</a:tr>
              <a:tr h="245880">
                <a:tc>
                  <a:txBody>
                    <a:bodyPr lIns="15480" rIns="15480" tIns="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fr-FR" sz="1400" spc="-1" strike="noStrike">
                          <a:solidFill>
                            <a:srgbClr val="000000"/>
                          </a:solidFill>
                          <a:latin typeface="Calibri"/>
                          <a:ea typeface="PMingLiU"/>
                        </a:rPr>
                        <a:t>Admission dat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600">
                <a:tc>
                  <a:txBody>
                    <a:bodyPr lIns="15480" rIns="15480" tIns="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MS Mincho"/>
                        </a:rPr>
                        <a:t>Gender,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MS Mincho"/>
                        </a:rPr>
                        <a:t>Mal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MS Mincho"/>
                        </a:rPr>
                        <a:t>160 (63%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MS Mincho"/>
                        </a:rPr>
                        <a:t>65 (66%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5880">
                <a:tc>
                  <a:txBody>
                    <a:bodyPr lIns="15480" rIns="15480" tIns="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MS Mincho"/>
                        </a:rPr>
                        <a:t>Ag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MS Mincho"/>
                        </a:rPr>
                        <a:t>67 [59, 77]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MS Mincho"/>
                        </a:rPr>
                        <a:t>70 [59, 77]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240">
                <a:tc>
                  <a:txBody>
                    <a:bodyPr lIns="15480" rIns="15480" tIns="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MS Mincho"/>
                        </a:rPr>
                        <a:t>SAPS II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MS Mincho"/>
                        </a:rPr>
                        <a:t>63 [51, 78]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MS Mincho"/>
                        </a:rPr>
                        <a:t>63 [52, 72]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5880">
                <a:tc>
                  <a:txBody>
                    <a:bodyPr lIns="15480" rIns="15480" tIns="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MS Mincho"/>
                        </a:rPr>
                        <a:t>SOFA score on day 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MS Mincho"/>
                        </a:rPr>
                        <a:t>11 [9, 14]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MS Mincho"/>
                        </a:rPr>
                        <a:t>12 [9, 14]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600">
                <a:tc>
                  <a:txBody>
                    <a:bodyPr lIns="15480" rIns="15480" tIns="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fr-FR" sz="1400" spc="-1" strike="noStrike">
                          <a:solidFill>
                            <a:srgbClr val="000000"/>
                          </a:solidFill>
                          <a:latin typeface="Calibri"/>
                          <a:ea typeface="PMingLiU"/>
                        </a:rPr>
                        <a:t>Molecular Marker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5880">
                <a:tc>
                  <a:txBody>
                    <a:bodyPr lIns="15480" rIns="15480" tIns="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Calibri"/>
                          <a:ea typeface="PMingLiU"/>
                        </a:rPr>
                        <a:t>CD74 (Day 3/Day 1; CNRQ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PMingLiU"/>
                        </a:rPr>
                        <a:t>1.252 [0.839 , 1.760]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PMingLiU"/>
                        </a:rPr>
                        <a:t>1.225 [0.685 , 1.710]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240">
                <a:tc>
                  <a:txBody>
                    <a:bodyPr lIns="15480" rIns="15480" tIns="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Calibri"/>
                          <a:ea typeface="PMingLiU"/>
                        </a:rPr>
                        <a:t>IL10 (Day 3; NRQ)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PMingLiU"/>
                        </a:rPr>
                        <a:t>0.035 [0.021 , 0.055]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PMingLiU"/>
                        </a:rPr>
                        <a:t>0.035 [0.023 , 0.058]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5880">
                <a:tc>
                  <a:txBody>
                    <a:bodyPr lIns="15480" rIns="15480" tIns="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Calibri"/>
                          <a:ea typeface="PMingLiU"/>
                        </a:rPr>
                        <a:t>CX3CR1 (Day 3, CNRQ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PMingLiU"/>
                        </a:rPr>
                        <a:t>0.328 [0.112 , 0.503]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PMingLiU"/>
                        </a:rPr>
                        <a:t>0.210 [0.098 , 0.384]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600">
                <a:tc>
                  <a:txBody>
                    <a:bodyPr lIns="15480" rIns="15480" tIns="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Calibri"/>
                          <a:ea typeface="PMingLiU"/>
                        </a:rPr>
                        <a:t>IL1</a:t>
                      </a: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</a:t>
                      </a: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Calibri"/>
                          <a:ea typeface="PMingLiU"/>
                        </a:rPr>
                        <a:t>(Day3, CNRQ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PMingLiU"/>
                        </a:rPr>
                        <a:t>1.625 [0.977 , 2.016]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PMingLiU"/>
                        </a:rPr>
                        <a:t>1.336 [1.046 , 2.140]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5880">
                <a:tc>
                  <a:txBody>
                    <a:bodyPr lIns="15480" rIns="15480" tIns="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fr-FR" sz="1400" spc="-1" strike="noStrike">
                          <a:solidFill>
                            <a:srgbClr val="000000"/>
                          </a:solidFill>
                          <a:latin typeface="Calibri"/>
                          <a:ea typeface="PMingLiU"/>
                        </a:rPr>
                        <a:t>Outcom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240">
                <a:tc>
                  <a:txBody>
                    <a:bodyPr lIns="15480" rIns="15480" tIns="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MS Mincho"/>
                        </a:rPr>
                        <a:t>ICU length of stay (days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MS Mincho"/>
                        </a:rPr>
                        <a:t> </a:t>
                      </a: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Calibri"/>
                          <a:ea typeface="MS Mincho"/>
                        </a:rPr>
                        <a:t>7 [4, 15]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MS Mincho"/>
                        </a:rPr>
                        <a:t> </a:t>
                      </a: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Calibri"/>
                          <a:ea typeface="PMingLiU"/>
                        </a:rPr>
                        <a:t>14 [9-21]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5880">
                <a:tc>
                  <a:txBody>
                    <a:bodyPr lIns="15480" rIns="15480" tIns="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Calibri"/>
                          <a:ea typeface="PMingLiU"/>
                        </a:rPr>
                        <a:t>Survival D2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Calibri"/>
                          <a:ea typeface="MS Mincho"/>
                        </a:rPr>
                        <a:t>169 (66%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Calibri"/>
                          <a:ea typeface="MS Mincho"/>
                        </a:rPr>
                        <a:t>77 (79%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240">
                <a:tc>
                  <a:txBody>
                    <a:bodyPr lIns="15480" rIns="15480" tIns="0" bIns="0" anchor="ctr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Calibri"/>
                          <a:ea typeface="PMingLiU"/>
                        </a:rPr>
                        <a:t>At least one IAI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Calibri"/>
                          <a:ea typeface="PMingLiU"/>
                        </a:rPr>
                        <a:t>40 (16%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5480" rIns="15480" tIns="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400" spc="-1" strike="noStrike">
                          <a:solidFill>
                            <a:srgbClr val="000000"/>
                          </a:solidFill>
                          <a:latin typeface="Calibri"/>
                          <a:ea typeface="PMingLiU"/>
                        </a:rPr>
                        <a:t>25 (26%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5480" marR="154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pSp>
        <p:nvGrpSpPr>
          <p:cNvPr id="82" name=""/>
          <p:cNvGrpSpPr/>
          <p:nvPr/>
        </p:nvGrpSpPr>
        <p:grpSpPr>
          <a:xfrm>
            <a:off x="5334120" y="1000080"/>
            <a:ext cx="2080440" cy="3840120"/>
            <a:chOff x="5334120" y="1000080"/>
            <a:chExt cx="2080440" cy="3840120"/>
          </a:xfrm>
        </p:grpSpPr>
        <p:sp>
          <p:nvSpPr>
            <p:cNvPr id="83" name=""/>
            <p:cNvSpPr/>
            <p:nvPr/>
          </p:nvSpPr>
          <p:spPr>
            <a:xfrm rot="5400000">
              <a:off x="4454640" y="1880280"/>
              <a:ext cx="3840120" cy="2079720"/>
            </a:xfrm>
            <a:prstGeom prst="roundRect">
              <a:avLst>
                <a:gd name="adj" fmla="val 8412"/>
              </a:avLst>
            </a:prstGeom>
            <a:noFill/>
            <a:ln cap="sq" w="2844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5334120" y="2104920"/>
              <a:ext cx="0" cy="473040"/>
            </a:xfrm>
            <a:prstGeom prst="line">
              <a:avLst/>
            </a:prstGeom>
            <a:ln cap="sq" w="507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5334120" y="3462480"/>
              <a:ext cx="0" cy="361800"/>
            </a:xfrm>
            <a:prstGeom prst="line">
              <a:avLst/>
            </a:prstGeom>
            <a:ln cap="sq" w="507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cxnSp>
        <p:nvCxnSpPr>
          <p:cNvPr id="86" name=""/>
          <p:cNvCxnSpPr/>
          <p:nvPr/>
        </p:nvCxnSpPr>
        <p:spPr>
          <a:xfrm flipH="1">
            <a:off x="5241600" y="4829040"/>
            <a:ext cx="141840" cy="278280"/>
          </a:xfrm>
          <a:prstGeom prst="straightConnector1">
            <a:avLst/>
          </a:prstGeom>
          <a:ln cap="sq" w="1260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87" name=""/>
          <p:cNvCxnSpPr/>
          <p:nvPr/>
        </p:nvCxnSpPr>
        <p:spPr>
          <a:xfrm>
            <a:off x="4103280" y="5849640"/>
            <a:ext cx="2520" cy="253080"/>
          </a:xfrm>
          <a:prstGeom prst="straightConnector1">
            <a:avLst/>
          </a:prstGeom>
          <a:ln cap="sq" w="1260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88" name=""/>
          <p:cNvSpPr/>
          <p:nvPr/>
        </p:nvSpPr>
        <p:spPr>
          <a:xfrm>
            <a:off x="468360" y="10366200"/>
            <a:ext cx="6805440" cy="31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pPr algn="just">
              <a:spcBef>
                <a:spcPts val="300"/>
              </a:spcBef>
              <a:tabLst>
                <a:tab algn="l" pos="0"/>
                <a:tab algn="l" pos="569880"/>
                <a:tab algn="l" pos="1484280"/>
                <a:tab algn="l" pos="2398680"/>
                <a:tab algn="l" pos="3313080"/>
                <a:tab algn="l" pos="4227480"/>
                <a:tab algn="l" pos="5141880"/>
                <a:tab algn="l" pos="6056280"/>
                <a:tab algn="l" pos="6970680"/>
                <a:tab algn="l" pos="7885080"/>
                <a:tab algn="l" pos="8799480"/>
                <a:tab algn="l" pos="9713880"/>
                <a:tab algn="l" pos="10058400"/>
                <a:tab algn="l" pos="105156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Calibri"/>
                <a:ea typeface="Microsoft YaHei"/>
              </a:rPr>
              <a:t>Figure S1. 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  <a:ea typeface="Microsoft YaHei"/>
              </a:rPr>
              <a:t>Selection of the so-called « Viral cohort », a subset of the MIP REA cohort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dur="indefinite" nodeType="clickEffect" fill="hold">
                      <p:stCondLst>
                        <p:cond delay="indefinite"/>
                      </p:stCondLst>
                      <p:childTnLst>
                        <p:par>
                          <p:cTn id="4" dur="indefinite" nodeType="click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5" dur="indefinite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dur="indefinite" nodeType="clickEffect" fill="hold">
                      <p:stCondLst>
                        <p:cond delay="indefinite"/>
                      </p:stCondLst>
                      <p:childTnLst>
                        <p:par>
                          <p:cTn id="8" dur="indefinite" nodeType="click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9" dur="indefinite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0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dur="indefinite" nodeType="clickEffect" fill="hold">
                      <p:stCondLst>
                        <p:cond delay="indefinite"/>
                      </p:stCondLst>
                      <p:childTnLst>
                        <p:par>
                          <p:cTn id="12" dur="indefinite" nodeType="click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13" dur="indefinite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0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dur="indefinite" nodeType="clickEffect" fill="hold">
                      <p:stCondLst>
                        <p:cond delay="indefinite"/>
                      </p:stCondLst>
                      <p:childTnLst>
                        <p:par>
                          <p:cTn id="16" dur="indefinite" nodeType="click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17" dur="indefinite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9" name="" descr=""/>
          <p:cNvPicPr/>
          <p:nvPr/>
        </p:nvPicPr>
        <p:blipFill>
          <a:blip r:embed="rId1"/>
          <a:stretch/>
        </p:blipFill>
        <p:spPr>
          <a:xfrm>
            <a:off x="396720" y="593640"/>
            <a:ext cx="6588360" cy="3981600"/>
          </a:xfrm>
          <a:prstGeom prst="rect">
            <a:avLst/>
          </a:prstGeom>
          <a:ln w="0">
            <a:noFill/>
          </a:ln>
        </p:spPr>
      </p:pic>
      <p:sp>
        <p:nvSpPr>
          <p:cNvPr id="90" name=""/>
          <p:cNvSpPr/>
          <p:nvPr/>
        </p:nvSpPr>
        <p:spPr>
          <a:xfrm>
            <a:off x="468360" y="9594720"/>
            <a:ext cx="6805440" cy="60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just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Calibri"/>
                <a:ea typeface="Arial"/>
              </a:rPr>
              <a:t>Figure S2. 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  <a:ea typeface="Arial"/>
              </a:rPr>
              <a:t>(A) Semi-automated procedure applied to detect DNA viremia in plasma. Internal controls are used all along the process to qualify each single step, namely extraction, amplification, detection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"/>
          <p:cNvSpPr/>
          <p:nvPr/>
        </p:nvSpPr>
        <p:spPr>
          <a:xfrm>
            <a:off x="324000" y="9450360"/>
            <a:ext cx="6805440" cy="809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pPr algn="just">
              <a:spcBef>
                <a:spcPts val="300"/>
              </a:spcBef>
              <a:tabLst>
                <a:tab algn="l" pos="0"/>
                <a:tab algn="l" pos="569880"/>
                <a:tab algn="l" pos="1484280"/>
                <a:tab algn="l" pos="2398680"/>
                <a:tab algn="l" pos="3313080"/>
                <a:tab algn="l" pos="4227480"/>
                <a:tab algn="l" pos="5141880"/>
                <a:tab algn="l" pos="6056280"/>
                <a:tab algn="l" pos="6970680"/>
                <a:tab algn="l" pos="7885080"/>
                <a:tab algn="l" pos="8799480"/>
                <a:tab algn="l" pos="9713880"/>
                <a:tab algn="l" pos="10058400"/>
                <a:tab algn="l" pos="105156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Calibri"/>
                <a:ea typeface="Microsoft YaHei"/>
              </a:rPr>
              <a:t>Figure S3. 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  <a:ea typeface="Microsoft YaHei"/>
              </a:rPr>
              <a:t>(A) Procedure applied to determine the LOD (B) Last performed dilution giving a positive count and selection (red) of the LOD (left), and amplification on blood extracts from healthy volunteers; (a) TTV LOD in plasma was derived from  Kulifaj D. et al, 2018  (https://doi.org/10.1016/j.jcv.2018.06.010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2" name="" descr=""/>
          <p:cNvPicPr/>
          <p:nvPr/>
        </p:nvPicPr>
        <p:blipFill>
          <a:blip r:embed="rId1"/>
          <a:stretch/>
        </p:blipFill>
        <p:spPr>
          <a:xfrm>
            <a:off x="1812960" y="233280"/>
            <a:ext cx="3647880" cy="2887920"/>
          </a:xfrm>
          <a:prstGeom prst="rect">
            <a:avLst/>
          </a:prstGeom>
          <a:ln w="0">
            <a:noFill/>
          </a:ln>
        </p:spPr>
      </p:pic>
      <p:sp>
        <p:nvSpPr>
          <p:cNvPr id="93" name=""/>
          <p:cNvSpPr/>
          <p:nvPr/>
        </p:nvSpPr>
        <p:spPr>
          <a:xfrm>
            <a:off x="180720" y="23328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  <a:ea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"/>
          <p:cNvSpPr/>
          <p:nvPr/>
        </p:nvSpPr>
        <p:spPr>
          <a:xfrm>
            <a:off x="181440" y="311472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  <a:ea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95" name=""/>
          <p:cNvGraphicFramePr/>
          <p:nvPr/>
        </p:nvGraphicFramePr>
        <p:xfrm>
          <a:off x="309600" y="4016520"/>
          <a:ext cx="3346200" cy="4038120"/>
        </p:xfrm>
        <a:graphic>
          <a:graphicData uri="http://schemas.openxmlformats.org/drawingml/2006/table">
            <a:tbl>
              <a:tblPr/>
              <a:tblGrid>
                <a:gridCol w="625320"/>
                <a:gridCol w="726480"/>
                <a:gridCol w="682920"/>
                <a:gridCol w="633240"/>
                <a:gridCol w="678240"/>
              </a:tblGrid>
              <a:tr h="417240">
                <a:tc>
                  <a:txBody>
                    <a:bodyPr lIns="75600" rIns="75600" tIns="43920" bIns="37800" anchor="ctr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0" rIns="75600" tIns="43920" bIns="3780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BV</a:t>
                      </a:r>
                      <a:br>
                        <a:rPr sz="700"/>
                      </a:b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1/20 mdQ)</a:t>
                      </a:r>
                      <a:br>
                        <a:rPr sz="700"/>
                      </a:b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p/ml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0" rIns="75600" tIns="43920" bIns="3780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MV</a:t>
                      </a:r>
                      <a:br>
                        <a:rPr sz="700"/>
                      </a:b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1/10 mdQ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p/ml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0" rIns="75600" tIns="43920" bIns="3780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SV1</a:t>
                      </a:r>
                      <a:br>
                        <a:rPr sz="700"/>
                      </a:b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1/10 mdQ)</a:t>
                      </a:r>
                      <a:br>
                        <a:rPr sz="700"/>
                      </a:b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p/ml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0" rIns="75600" tIns="43920" bIns="3780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HV-6</a:t>
                      </a:r>
                      <a:br>
                        <a:rPr sz="700"/>
                      </a:b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1/10 last+)</a:t>
                      </a:r>
                      <a:br>
                        <a:rPr sz="700"/>
                      </a:b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p/ml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73160">
                <a:tc>
                  <a:txBody>
                    <a:bodyPr lIns="7920" rIns="7920" tIns="14040" bIns="0" anchor="ctr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lasma 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9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6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173160">
                <a:tc>
                  <a:txBody>
                    <a:bodyPr lIns="7920" rIns="7920" tIns="14040" bIns="0" anchor="ctr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lasma 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3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2800">
                <a:tc>
                  <a:txBody>
                    <a:bodyPr lIns="7920" rIns="7920" tIns="14040" bIns="0" anchor="ctr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lasma 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9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6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173520">
                <a:tc>
                  <a:txBody>
                    <a:bodyPr lIns="7920" rIns="7920" tIns="14040" bIns="0" anchor="ctr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lasma 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3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3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3160">
                <a:tc>
                  <a:txBody>
                    <a:bodyPr lIns="7920" rIns="7920" tIns="14040" bIns="0" anchor="ctr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lasma 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6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6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9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172800">
                <a:tc>
                  <a:txBody>
                    <a:bodyPr lIns="7920" rIns="7920" tIns="14040" bIns="0" anchor="ctr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lasma 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6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6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9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3160">
                <a:tc>
                  <a:txBody>
                    <a:bodyPr lIns="7920" rIns="7920" tIns="14040" bIns="0" anchor="ctr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lasma 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9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6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173160">
                <a:tc>
                  <a:txBody>
                    <a:bodyPr lIns="7920" rIns="7920" tIns="14040" bIns="0" anchor="ctr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lasma 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6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6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2800">
                <a:tc>
                  <a:txBody>
                    <a:bodyPr lIns="7920" rIns="7920" tIns="14040" bIns="0" anchor="ctr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lasma 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9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6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173520">
                <a:tc>
                  <a:txBody>
                    <a:bodyPr lIns="7920" rIns="7920" tIns="14040" bIns="0" anchor="ctr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lasma 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9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6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89000">
                <a:tc>
                  <a:txBody>
                    <a:bodyPr lIns="7920" rIns="7920" tIns="14040" bIns="0" anchor="ctr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lasma 1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5600" rIns="75600" tIns="43920" bIns="3780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188640">
                <a:tc>
                  <a:txBody>
                    <a:bodyPr lIns="7920" rIns="7920" tIns="14040" bIns="0" anchor="ctr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lasma 1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6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0" rIns="75600" tIns="43920" bIns="3780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89000">
                <a:tc>
                  <a:txBody>
                    <a:bodyPr lIns="7920" rIns="7920" tIns="14040" bIns="0" anchor="ctr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lasma 1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6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9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5600" rIns="75600" tIns="43920" bIns="3780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189000">
                <a:tc>
                  <a:txBody>
                    <a:bodyPr lIns="7920" rIns="7920" tIns="14040" bIns="0" anchor="ctr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lasma 1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3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0" rIns="75600" tIns="43920" bIns="3780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89360">
                <a:tc>
                  <a:txBody>
                    <a:bodyPr lIns="7920" rIns="7920" tIns="14040" bIns="0" anchor="ctr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lasma 1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3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5600" rIns="75600" tIns="43920" bIns="3780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5600" rIns="75600" tIns="43920" bIns="3780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188640">
                <a:tc>
                  <a:txBody>
                    <a:bodyPr lIns="7920" rIns="7920" tIns="14040" bIns="0" anchor="ctr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lasma 1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6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0" rIns="75600" tIns="43920" bIns="3780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0" rIns="75600" tIns="43920" bIns="3780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89000">
                <a:tc>
                  <a:txBody>
                    <a:bodyPr lIns="7920" rIns="7920" tIns="14040" bIns="0" anchor="ctr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lasma 1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9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3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5600" rIns="75600" tIns="43920" bIns="3780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5600" rIns="75600" tIns="43920" bIns="3780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189000">
                <a:tc>
                  <a:txBody>
                    <a:bodyPr lIns="7920" rIns="7920" tIns="14040" bIns="0" anchor="ctr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lasma 1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9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0" rIns="75600" tIns="43920" bIns="3780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0" rIns="75600" tIns="43920" bIns="3780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89000">
                <a:tc>
                  <a:txBody>
                    <a:bodyPr lIns="7920" rIns="7920" tIns="14040" bIns="0" anchor="ctr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lasma 1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3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5600" rIns="75600" tIns="43920" bIns="3780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5600" rIns="75600" tIns="43920" bIns="3780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189000">
                <a:tc>
                  <a:txBody>
                    <a:bodyPr lIns="7920" rIns="7920" tIns="14040" bIns="0" anchor="ctr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lasma 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9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0" rIns="75600" tIns="43920" bIns="3780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0" rIns="75600" tIns="43920" bIns="3780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96" name=""/>
          <p:cNvSpPr/>
          <p:nvPr/>
        </p:nvSpPr>
        <p:spPr>
          <a:xfrm>
            <a:off x="324000" y="3475080"/>
            <a:ext cx="3328920" cy="511200"/>
          </a:xfrm>
          <a:prstGeom prst="rect">
            <a:avLst/>
          </a:pr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08000" rIns="0" tIns="0" bIns="0" anchor="ctr">
            <a:noAutofit/>
          </a:bodyPr>
          <a:p>
            <a:pPr algn="ctr">
              <a:spcBef>
                <a:spcPts val="26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fr-FR" sz="1400" spc="-1" strike="noStrike">
                <a:solidFill>
                  <a:srgbClr val="004080"/>
                </a:solidFill>
                <a:latin typeface="Calibri"/>
                <a:ea typeface="MS PGothic"/>
              </a:rPr>
              <a:t>SERIAL DILUTIONS ON REFERENCE PANE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fr-FR" sz="1400" spc="-1" strike="noStrike">
                <a:solidFill>
                  <a:srgbClr val="004080"/>
                </a:solidFill>
                <a:latin typeface="Calibri"/>
                <a:ea typeface="MS PGothic"/>
              </a:rPr>
              <a:t>(copies/ml of plasma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97" name=""/>
          <p:cNvGraphicFramePr/>
          <p:nvPr/>
        </p:nvGraphicFramePr>
        <p:xfrm>
          <a:off x="339840" y="8186760"/>
          <a:ext cx="3314160" cy="979200"/>
        </p:xfrm>
        <a:graphic>
          <a:graphicData uri="http://schemas.openxmlformats.org/drawingml/2006/table">
            <a:tbl>
              <a:tblPr/>
              <a:tblGrid>
                <a:gridCol w="726840"/>
                <a:gridCol w="656280"/>
                <a:gridCol w="633600"/>
                <a:gridCol w="625680"/>
                <a:gridCol w="671760"/>
              </a:tblGrid>
              <a:tr h="387360">
                <a:tc>
                  <a:txBody>
                    <a:bodyPr lIns="75600" rIns="75600" tIns="43920" bIns="37800" anchor="t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5600" marR="75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0" rIns="75600" tIns="43920" bIns="37800" anchor="t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BV</a:t>
                      </a:r>
                      <a:br>
                        <a:rPr sz="700"/>
                      </a:b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1/20 mdQ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5600" marR="75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0" rIns="75600" tIns="43920" bIns="37800" anchor="t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MV</a:t>
                      </a:r>
                      <a:br>
                        <a:rPr sz="700"/>
                      </a:b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1/10 mdQ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5600" marR="75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0" rIns="75600" tIns="43920" bIns="37800" anchor="t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SV1</a:t>
                      </a:r>
                      <a:br>
                        <a:rPr sz="700"/>
                      </a:b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1/10 mdQ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5600" marR="75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0" rIns="75600" tIns="43920" bIns="37800" anchor="t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HV-6</a:t>
                      </a:r>
                      <a:br>
                        <a:rPr sz="700"/>
                      </a:b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1/10 last+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75600" marR="75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960"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3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6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147960"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oy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4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4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2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47960"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i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ff0000"/>
                          </a:solidFill>
                          <a:latin typeface="Calibri"/>
                        </a:rPr>
                        <a:t>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ff0000"/>
                          </a:solidFill>
                          <a:latin typeface="Calibri"/>
                        </a:rPr>
                        <a:t>1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ff0000"/>
                          </a:solidFill>
                          <a:latin typeface="Calibri"/>
                        </a:rPr>
                        <a:t>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ff0000"/>
                          </a:solidFill>
                          <a:latin typeface="Calibri"/>
                        </a:rPr>
                        <a:t>16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147960"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a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6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9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3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98" name=""/>
          <p:cNvSpPr/>
          <p:nvPr/>
        </p:nvSpPr>
        <p:spPr>
          <a:xfrm>
            <a:off x="3825720" y="3479760"/>
            <a:ext cx="3195720" cy="498600"/>
          </a:xfrm>
          <a:prstGeom prst="rect">
            <a:avLst/>
          </a:pr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08000" rIns="0" tIns="0" bIns="0" anchor="ctr">
            <a:noAutofit/>
          </a:bodyPr>
          <a:p>
            <a:pPr algn="ctr">
              <a:spcBef>
                <a:spcPts val="26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fr-FR" sz="1400" spc="-1" strike="noStrike">
                <a:solidFill>
                  <a:srgbClr val="004080"/>
                </a:solidFill>
                <a:latin typeface="Calibri"/>
                <a:ea typeface="MS PGothic"/>
              </a:rPr>
              <a:t>AMPLIFICATION ON EFS INDIVIDUALS (copies/ml of plasma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99" name=""/>
          <p:cNvGraphicFramePr/>
          <p:nvPr/>
        </p:nvGraphicFramePr>
        <p:xfrm>
          <a:off x="3855960" y="4027320"/>
          <a:ext cx="3165120" cy="4055760"/>
        </p:xfrm>
        <a:graphic>
          <a:graphicData uri="http://schemas.openxmlformats.org/drawingml/2006/table">
            <a:tbl>
              <a:tblPr/>
              <a:tblGrid>
                <a:gridCol w="906840"/>
                <a:gridCol w="414360"/>
                <a:gridCol w="373320"/>
                <a:gridCol w="436680"/>
                <a:gridCol w="454320"/>
                <a:gridCol w="579600"/>
              </a:tblGrid>
              <a:tr h="393480">
                <a:tc>
                  <a:txBody>
                    <a:bodyPr lIns="75600" rIns="75600" tIns="43920" bIns="37800" anchor="ctr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0" rIns="75600" tIns="43920" bIns="3780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BV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0" rIns="75600" tIns="43920" bIns="3780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MV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0" rIns="75600" tIns="43920" bIns="3780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SV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0" rIns="75600" tIns="43920" bIns="3780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HV-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0" rIns="75600" tIns="43920" bIns="3780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TV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72440"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FS_457541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9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172440"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FS_457543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1512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2080"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FS_457054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lt;16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172800"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FS_45755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1512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2440"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FS_45705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lt;16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172080"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FS_4570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9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2440"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FS_457013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1512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172440"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FS_457015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lt;16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2080"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FS_457016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31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172800"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FS_457024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lt;16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15640"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FS_447091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5600" rIns="75600" tIns="37800" bIns="3780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215640"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FS_447162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0" rIns="75600" tIns="37800" bIns="3780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lt;16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15640"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FS_447095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5600" rIns="75600" tIns="37800" bIns="3780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lt;16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215640"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FS_447096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0" rIns="75600" tIns="37800" bIns="3780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lt;16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15640"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FS_447097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5600" rIns="75600" tIns="37800" bIns="3780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5600" rIns="75600" tIns="37800" bIns="3780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1512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215640"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FS_447100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0" rIns="75600" tIns="37800" bIns="3780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0" rIns="75600" tIns="37800" bIns="3780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lt;16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15640"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FS_447208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5600" rIns="75600" tIns="37800" bIns="3780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5600" rIns="75600" tIns="37800" bIns="3780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215640"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FS_447210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0" rIns="75600" tIns="37800" bIns="3780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0" rIns="75600" tIns="37800" bIns="3780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lt;16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15640"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FS_44721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5600" rIns="75600" tIns="37800" bIns="3780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5600" rIns="75600" tIns="37800" bIns="3780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lt;16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100" name=""/>
          <p:cNvGraphicFramePr/>
          <p:nvPr/>
        </p:nvGraphicFramePr>
        <p:xfrm>
          <a:off x="3857760" y="8151840"/>
          <a:ext cx="3165120" cy="1022040"/>
        </p:xfrm>
        <a:graphic>
          <a:graphicData uri="http://schemas.openxmlformats.org/drawingml/2006/table">
            <a:tbl>
              <a:tblPr/>
              <a:tblGrid>
                <a:gridCol w="906840"/>
                <a:gridCol w="414720"/>
                <a:gridCol w="372960"/>
                <a:gridCol w="436680"/>
                <a:gridCol w="454680"/>
                <a:gridCol w="579240"/>
              </a:tblGrid>
              <a:tr h="362160">
                <a:tc>
                  <a:txBody>
                    <a:bodyPr lIns="75600" rIns="75600" tIns="43920" bIns="37800" anchor="ctr">
                      <a:noAutofit/>
                    </a:bodyPr>
                    <a:p>
                      <a:pPr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0" rIns="75600" tIns="43920" bIns="3780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BV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0" rIns="75600" tIns="43920" bIns="3780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MV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0" rIns="75600" tIns="43920" bIns="3780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SV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0" rIns="75600" tIns="43920" bIns="3780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HV-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0" rIns="75600" tIns="43920" bIns="3780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TV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59480"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ositive PC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4 (70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213120"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0" rIns="75600" tIns="37800" bIns="3780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5600" rIns="75600" tIns="37800" bIns="3780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5600" marR="75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87640"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ositive sampl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(LOD = </a:t>
                      </a:r>
                      <a:r>
                        <a:rPr b="0" lang="fr-FR" sz="900" spc="-1" strike="noStrike">
                          <a:solidFill>
                            <a:srgbClr val="ff0000"/>
                          </a:solidFill>
                          <a:latin typeface="Calibri"/>
                        </a:rPr>
                        <a:t>167</a:t>
                      </a: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cp/ml)</a:t>
                      </a:r>
                      <a:r>
                        <a:rPr b="0" lang="fr-FR" sz="9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 (20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</a:tr>
            </a:tbl>
          </a:graphicData>
        </a:graphic>
      </p:graphicFrame>
    </p:spTree>
  </p:cSld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"/>
          <p:cNvSpPr/>
          <p:nvPr/>
        </p:nvSpPr>
        <p:spPr>
          <a:xfrm>
            <a:off x="468360" y="8083440"/>
            <a:ext cx="6805440" cy="1871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pPr algn="just">
              <a:spcBef>
                <a:spcPts val="300"/>
              </a:spcBef>
              <a:tabLst>
                <a:tab algn="l" pos="0"/>
                <a:tab algn="l" pos="569880"/>
                <a:tab algn="l" pos="1484280"/>
                <a:tab algn="l" pos="2398680"/>
                <a:tab algn="l" pos="3313080"/>
                <a:tab algn="l" pos="4227480"/>
                <a:tab algn="l" pos="5141880"/>
                <a:tab algn="l" pos="6056280"/>
                <a:tab algn="l" pos="6970680"/>
                <a:tab algn="l" pos="7885080"/>
                <a:tab algn="l" pos="8799480"/>
                <a:tab algn="l" pos="9713880"/>
                <a:tab algn="l" pos="10058400"/>
                <a:tab algn="l" pos="105156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Calibri"/>
                <a:ea typeface="Microsoft YaHei"/>
              </a:rPr>
              <a:t>Table S2.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  <a:ea typeface="Microsoft YaHei"/>
              </a:rPr>
              <a:t> Association between binary endpoints or markers and viremia presence. Clinical outcomes are mortality at D28 following ICU admission and HAI occurrence occuring during the hospitalization. Biomarkers, quantified by RT-PCR, consisted of CD74 ratio of D3/D1 (&gt; 1.238 = increased incidence of HAI), CX3CR1 mesasured at D3  (&gt; 0.253 = increased incidence of mortality at D28) , IL10 mesasured at D3 (&gt; 0.039 = increased incidence of HAI) , and IL1</a:t>
            </a:r>
            <a:r>
              <a:rPr b="0" lang="fr-FR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  <a:ea typeface="Microsoft YaHei"/>
              </a:rPr>
              <a:t>  measured at D3 (increase at D2-D4 = increase  incidence of HAI in pediatric patients). Thresholds were determined using the total MIPREA cohort, for CD74 and IL10 (Peronnet E et al, 2017) and CX3CR1 as well (Friggeri A et al, 2016, Peronnet E et al, 2016). As no threshold was proposed for IL1</a:t>
            </a:r>
            <a:r>
              <a:rPr b="0" lang="fr-FR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  <a:ea typeface="Microsoft YaHei"/>
              </a:rPr>
              <a:t>  (Peronnet E et al, 2016), it was used as a continuous variable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spcBef>
                <a:spcPts val="300"/>
              </a:spcBef>
              <a:tabLst>
                <a:tab algn="l" pos="0"/>
                <a:tab algn="l" pos="569880"/>
                <a:tab algn="l" pos="1484280"/>
                <a:tab algn="l" pos="2398680"/>
                <a:tab algn="l" pos="3313080"/>
                <a:tab algn="l" pos="4227480"/>
                <a:tab algn="l" pos="5141880"/>
                <a:tab algn="l" pos="6056280"/>
                <a:tab algn="l" pos="6970680"/>
                <a:tab algn="l" pos="7885080"/>
                <a:tab algn="l" pos="8799480"/>
                <a:tab algn="l" pos="9713880"/>
                <a:tab algn="l" pos="10058400"/>
                <a:tab algn="l" pos="10515600"/>
              </a:tabLst>
            </a:pPr>
            <a:r>
              <a:rPr b="0" lang="fr-FR" sz="1200" spc="-1" strike="noStrike" baseline="30000">
                <a:solidFill>
                  <a:srgbClr val="000000"/>
                </a:solidFill>
                <a:latin typeface="Calibri"/>
                <a:ea typeface="Microsoft YaHei"/>
              </a:rPr>
              <a:t>a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  <a:ea typeface="Microsoft YaHei"/>
              </a:rPr>
              <a:t> IL1b not a binary endpoin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02" name=""/>
          <p:cNvGraphicFramePr/>
          <p:nvPr/>
        </p:nvGraphicFramePr>
        <p:xfrm>
          <a:off x="1044720" y="1098720"/>
          <a:ext cx="5546160" cy="2699640"/>
        </p:xfrm>
        <a:graphic>
          <a:graphicData uri="http://schemas.openxmlformats.org/drawingml/2006/table">
            <a:tbl>
              <a:tblPr/>
              <a:tblGrid>
                <a:gridCol w="693720"/>
                <a:gridCol w="811440"/>
                <a:gridCol w="633240"/>
                <a:gridCol w="297000"/>
                <a:gridCol w="743400"/>
                <a:gridCol w="811080"/>
                <a:gridCol w="744840"/>
                <a:gridCol w="811440"/>
              </a:tblGrid>
              <a:tr h="639720"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Arial"/>
                          <a:ea typeface="MS PGothic"/>
                        </a:rPr>
                        <a:t>Clinical outcom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 gridSpan="4"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Arial"/>
                          <a:ea typeface="MS PGothic"/>
                        </a:rPr>
                        <a:t>mRNA biomarker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549360"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MS PGothic"/>
                        </a:rPr>
                        <a:t>Mortality at D2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MS PGothic"/>
                        </a:rPr>
                        <a:t>HAI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MS PGothic"/>
                        </a:rPr>
                        <a:t>CD74 (D3/D1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MS PGothic"/>
                        </a:rPr>
                        <a:t>IL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4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MS PGothic"/>
                        </a:rPr>
                        <a:t>(D3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MS PGothic"/>
                        </a:rPr>
                        <a:t>CX3CR1 (D3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L1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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9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4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D3)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</a:tr>
              <a:tr h="503640"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Arial"/>
                          <a:ea typeface="MS PGothic"/>
                        </a:rPr>
                        <a:t>EBV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MS PGothic"/>
                        </a:rPr>
                        <a:t>1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ff0000"/>
                          </a:solidFill>
                          <a:latin typeface="Arial"/>
                          <a:ea typeface="MS PGothic"/>
                        </a:rPr>
                        <a:t>0.07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MS PGothic"/>
                        </a:rPr>
                        <a:t>0.94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MS PGothic"/>
                        </a:rPr>
                        <a:t>0.18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ff0000"/>
                          </a:solidFill>
                          <a:latin typeface="Arial"/>
                          <a:ea typeface="MS PGothic"/>
                        </a:rPr>
                        <a:t>0.0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ff0000"/>
                          </a:solidFill>
                          <a:latin typeface="Arial"/>
                          <a:ea typeface="MS PGothic"/>
                        </a:rPr>
                        <a:t>0.03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503640"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Arial"/>
                          <a:ea typeface="MS PGothic"/>
                        </a:rPr>
                        <a:t>TTV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MS PGothic"/>
                        </a:rPr>
                        <a:t>0.85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MS PGothic"/>
                        </a:rPr>
                        <a:t>0.92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MS PGothic"/>
                        </a:rPr>
                        <a:t>0.88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MS PGothic"/>
                        </a:rPr>
                        <a:t>0.27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MS PGothic"/>
                        </a:rPr>
                        <a:t>0.7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MS PGothic"/>
                        </a:rPr>
                        <a:t>0.67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503280"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Arial"/>
                          <a:ea typeface="MS PGothic"/>
                        </a:rPr>
                        <a:t>HSV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MS PGothic"/>
                        </a:rPr>
                        <a:t>1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MS PGothic"/>
                        </a:rPr>
                        <a:t>1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MS PGothic"/>
                        </a:rPr>
                        <a:t>0.56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MS PGothic"/>
                        </a:rPr>
                        <a:t>1.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MS PGothic"/>
                        </a:rPr>
                        <a:t>0.24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  <a:tab algn="l" pos="105156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MS PGothic"/>
                        </a:rPr>
                        <a:t>0.25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7-05T14:34:57Z</dcterms:created>
  <dc:creator>MALLET Francois</dc:creator>
  <dc:description/>
  <dc:language>en-US</dc:language>
  <cp:lastModifiedBy>MALLET Francois</cp:lastModifiedBy>
  <cp:lastPrinted>2018-12-13T14:45:38Z</cp:lastPrinted>
  <dcterms:modified xsi:type="dcterms:W3CDTF">2019-04-08T14:01:39Z</dcterms:modified>
  <cp:revision>79</cp:revision>
  <dc:subject/>
  <dc:title>Présentation PowerPoint</dc:title>
</cp:coreProperties>
</file>